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85698" autoAdjust="0"/>
  </p:normalViewPr>
  <p:slideViewPr>
    <p:cSldViewPr>
      <p:cViewPr varScale="1">
        <p:scale>
          <a:sx n="62" d="100"/>
          <a:sy n="62" d="100"/>
        </p:scale>
        <p:origin x="1626" y="4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9E1626A-E5DB-4888-B6E9-B84407C3E8EF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66D5A9F-0F10-4483-BDCF-6A090BBB42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815406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Supplementary Figure 2:</a:t>
            </a:r>
            <a:r>
              <a:rPr lang="en-US" baseline="0" dirty="0"/>
              <a:t> 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hromosomal microarray performed on DNA extracted from FFPE tissue using the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ncoScan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NV Plus assay for ETT-2</a:t>
            </a:r>
            <a:endParaRPr lang="en-US" dirty="0"/>
          </a:p>
          <a:p>
            <a:endParaRPr lang="en-US" dirty="0"/>
          </a:p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TT-2 appeared to have gain of chromosome 5 as well as  reduced probe intensities supportive of a two-copy genomic deletion underlying the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LPCAT1-TERT</a:t>
            </a:r>
            <a:r>
              <a:rPr lang="en-US" sz="1200" i="1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usion. 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66D5A9F-0F10-4483-BDCF-6A090BBB4288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735921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32855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12159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1684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32179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71501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02996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7086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82842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57244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15118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94379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22789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43000" y="304800"/>
            <a:ext cx="7802902" cy="4236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36576" y="4648200"/>
            <a:ext cx="9166902" cy="1066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Rectangle 1"/>
          <p:cNvSpPr/>
          <p:nvPr/>
        </p:nvSpPr>
        <p:spPr>
          <a:xfrm>
            <a:off x="381000" y="368595"/>
            <a:ext cx="71199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ETT-2</a:t>
            </a:r>
          </a:p>
        </p:txBody>
      </p:sp>
      <p:sp>
        <p:nvSpPr>
          <p:cNvPr id="3" name="Rectangle 2"/>
          <p:cNvSpPr/>
          <p:nvPr/>
        </p:nvSpPr>
        <p:spPr>
          <a:xfrm>
            <a:off x="0" y="5715000"/>
            <a:ext cx="9144000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defRPr/>
            </a:pPr>
            <a:r>
              <a:rPr lang="en-US"/>
              <a:t>S2 Fig:  </a:t>
            </a:r>
            <a:r>
              <a:rPr lang="en-US" dirty="0"/>
              <a:t>Chromosomal microarray performed on DNA extracted from FFPE tissue using the </a:t>
            </a:r>
            <a:r>
              <a:rPr lang="en-US" dirty="0" err="1"/>
              <a:t>OncoScan</a:t>
            </a:r>
            <a:r>
              <a:rPr lang="en-US" dirty="0"/>
              <a:t> CNV Plus assay for ETT-2.  ETT-2 appeared to have gain of chromosome 5 as well as  reduced probe intensities supportive of a two-copy genomic deletion underlying the </a:t>
            </a:r>
            <a:r>
              <a:rPr lang="en-US" i="1" dirty="0"/>
              <a:t>LPCAT1-TERT </a:t>
            </a:r>
            <a:r>
              <a:rPr lang="en-US" dirty="0"/>
              <a:t>fusion. </a:t>
            </a:r>
          </a:p>
        </p:txBody>
      </p:sp>
    </p:spTree>
    <p:extLst>
      <p:ext uri="{BB962C8B-B14F-4D97-AF65-F5344CB8AC3E}">
        <p14:creationId xmlns:p14="http://schemas.microsoft.com/office/powerpoint/2010/main" val="21315066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80</TotalTime>
  <Words>94</Words>
  <Application>Microsoft Office PowerPoint</Application>
  <PresentationFormat>On-screen Show (4:3)</PresentationFormat>
  <Paragraphs>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Mayo Clini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icole L Hoppman</dc:creator>
  <cp:lastModifiedBy>chn off31</cp:lastModifiedBy>
  <cp:revision>18</cp:revision>
  <dcterms:created xsi:type="dcterms:W3CDTF">2019-10-11T15:47:09Z</dcterms:created>
  <dcterms:modified xsi:type="dcterms:W3CDTF">2021-05-15T05:14:28Z</dcterms:modified>
</cp:coreProperties>
</file>